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2" r:id="rId2"/>
    <p:sldId id="260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B301B821-A1FF-4177-AEE7-76D212191A09}" styleName="Medium Style 1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9" d="100"/>
          <a:sy n="69" d="100"/>
        </p:scale>
        <p:origin x="852" y="60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7C79D9B-98CD-4268-9C94-FEA8D3B89279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E5A9F8-8004-4628-A796-98B45497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409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6654ED-42F6-45C4-B15E-9B30D3020B5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11476BB-C541-46BD-899E-96267309F94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F025C0-F552-4326-A52F-D2FC7DD14F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8C7A6-86AA-485A-BE9F-C6F31CF2E04B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A3D812-EFF9-4254-99B4-89CB16BD21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D5C947-DB1A-4F7B-A08E-9AD58B876A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2689D-04A3-4EDC-ACA4-663F4B6A7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93819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31F287-2DCE-4350-BC35-300DA2E6D3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64ABA7F-FD2C-40BF-9AF2-95733079FF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4609F1-FBA6-4828-8446-4EB1074D0E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8C7A6-86AA-485A-BE9F-C6F31CF2E04B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420836-4394-49E5-B0DA-B9343985B4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1AF6A6-8237-474E-8A2E-5A5985F5B0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2689D-04A3-4EDC-ACA4-663F4B6A7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41025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D4F802F-5B64-4710-B2B0-21BEDF912AA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8E3EAA4-28CF-4775-86CF-8458715C7F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48BBDC-2041-4279-9823-3C9C4F0499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8C7A6-86AA-485A-BE9F-C6F31CF2E04B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9E6D8E-CD64-4226-8244-F435172B11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B87586-2A39-4968-940C-AA7719E4AA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2689D-04A3-4EDC-ACA4-663F4B6A7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15727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2338DA-6CFA-460B-83E8-CF7E57342A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F54368-6D67-429C-A366-72C85A3DDE1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C1991E-705C-4A92-A2BA-75C04EAAB4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8C7A6-86AA-485A-BE9F-C6F31CF2E04B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B6AC6B-D461-42FA-9B8E-72D8E0364D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97356A-0AF7-4446-8F03-F084728FF5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2689D-04A3-4EDC-ACA4-663F4B6A7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07966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305578-56D7-4558-9707-0AD6A86271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A02D4A-E5DA-41BF-BDF2-203CE4F980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63FF15-C116-4D6F-8D19-CDADA2FCF3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8C7A6-86AA-485A-BE9F-C6F31CF2E04B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142C4B-B0E3-4773-AA4B-5208605942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50B979-8091-4E70-AD5E-109C5989D1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2689D-04A3-4EDC-ACA4-663F4B6A7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00956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C37413-26F6-487E-93DC-C2EB42A329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032F5CC-D0A7-4BB5-AC11-7E06BF44609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113CCB1-792B-48E2-946F-C7DF6DFA9B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31F331E-57DC-46C9-B3D0-91441D8646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8C7A6-86AA-485A-BE9F-C6F31CF2E04B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A1EBDFD-BE91-40F9-AF38-5789B59B22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7445EA6-544C-4D30-ABAB-B5A659079A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2689D-04A3-4EDC-ACA4-663F4B6A7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05823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EE8507-6CF8-4629-8419-EB98CC50EB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7C950E9-7578-4411-80F9-979AFF4B54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2FCA305-A58E-4983-BB2C-AF6BC02D7F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6495FE3-D49E-42A8-B9E1-EF687C61A56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327CBB6-4B6F-4183-9E4F-22C05BF60EE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14239D4-9EF8-4062-AE0B-55AE51761D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8C7A6-86AA-485A-BE9F-C6F31CF2E04B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8E9A3DC-6769-488A-AC4F-4FC09D7404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DDFFE70-5B0D-4464-BFCD-26062B43D5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2689D-04A3-4EDC-ACA4-663F4B6A7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12901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0CEDDD-5B27-49AC-AEEE-B6C0B8FBD3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156E27B-F255-42CC-BA45-BD52F7109B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8C7A6-86AA-485A-BE9F-C6F31CF2E04B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53B6F09-768A-466A-8F4B-03DAAE6863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B674E87-9935-4715-ABF5-8FAFA16D31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2689D-04A3-4EDC-ACA4-663F4B6A7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4751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D103EE1-4C06-4BB7-AC5A-183D5792E3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8C7A6-86AA-485A-BE9F-C6F31CF2E04B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5C973B5-035B-4A74-BCF6-541B3722F8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8BD8E3E-C95D-4851-8421-D53C365868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2689D-04A3-4EDC-ACA4-663F4B6A7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37797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AE8336-BB45-4235-9E4C-445B32F1DD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6D78BF4-7F13-4D39-9986-688C4DF8011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478C2EB-591D-4B2C-9B3C-C7232F3BD1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91560D-0C09-4951-9EC7-E9B7BB4A46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8C7A6-86AA-485A-BE9F-C6F31CF2E04B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CD4E02D-1014-49C0-8367-070087828F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5770E99-0FB1-420D-B977-175CB6269C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2689D-04A3-4EDC-ACA4-663F4B6A7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2532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69910D-F920-4746-81B6-B6E782CE1D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9A6FAB0-76BB-48D4-9AE9-6926A6AF6B2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332D9E2-9B2F-4980-820E-07E908E18F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09F22D1-339B-4A58-9BC4-4E1027B127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8C7A6-86AA-485A-BE9F-C6F31CF2E04B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4410EF-ADCF-465F-9392-9F0E73F690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7327658-7715-423F-BD80-FA77336222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2689D-04A3-4EDC-ACA4-663F4B6A7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97375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A329207-BCE2-4696-9E32-63E7F273F5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3872EB-29ED-4B59-962F-24CC985AAF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DC97BA-1163-4129-AC8E-33E4E88570E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D8C7A6-86AA-485A-BE9F-C6F31CF2E04B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9BAECD-22F4-4CDF-B8E3-32EA1DB6677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D01F60-CA65-41DC-A26C-A78931E4D72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E2689D-04A3-4EDC-ACA4-663F4B6A7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72673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764C4EAC-F692-4BE3-A248-E6994EC396F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649" y="0"/>
            <a:ext cx="11726701" cy="6858000"/>
          </a:xfrm>
          <a:prstGeom prst="rect">
            <a:avLst/>
          </a:prstGeom>
        </p:spPr>
      </p:pic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5BCC8E13-3E3D-429A-BC09-D628E743768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11777262"/>
              </p:ext>
            </p:extLst>
          </p:nvPr>
        </p:nvGraphicFramePr>
        <p:xfrm>
          <a:off x="5192691" y="257716"/>
          <a:ext cx="6565491" cy="1150459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565491">
                  <a:extLst>
                    <a:ext uri="{9D8B030D-6E8A-4147-A177-3AD203B41FA5}">
                      <a16:colId xmlns:a16="http://schemas.microsoft.com/office/drawing/2014/main" val="44588833"/>
                    </a:ext>
                  </a:extLst>
                </a:gridCol>
              </a:tblGrid>
              <a:tr h="1150459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0" dirty="0">
                          <a:solidFill>
                            <a:schemeClr val="tx1"/>
                          </a:solidFill>
                          <a:effectLst/>
                        </a:rPr>
                        <a:t>Figure S1. Bland-Altman plots for global (A) and segmental (B) radial strains at end systole of basal, mid-ventricular, and apical slices computed using the conventional user-assisted and the fully-automated DL methods.</a:t>
                      </a:r>
                      <a:endParaRPr lang="en-US" sz="16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6071947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740120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CF4A26E6-F383-4EC9-9466-4ADC91E93D7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61458800"/>
              </p:ext>
            </p:extLst>
          </p:nvPr>
        </p:nvGraphicFramePr>
        <p:xfrm>
          <a:off x="1271015" y="649224"/>
          <a:ext cx="6245351" cy="2656344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2231135">
                  <a:extLst>
                    <a:ext uri="{9D8B030D-6E8A-4147-A177-3AD203B41FA5}">
                      <a16:colId xmlns:a16="http://schemas.microsoft.com/office/drawing/2014/main" val="3646393260"/>
                    </a:ext>
                  </a:extLst>
                </a:gridCol>
                <a:gridCol w="1188720">
                  <a:extLst>
                    <a:ext uri="{9D8B030D-6E8A-4147-A177-3AD203B41FA5}">
                      <a16:colId xmlns:a16="http://schemas.microsoft.com/office/drawing/2014/main" val="1863042051"/>
                    </a:ext>
                  </a:extLst>
                </a:gridCol>
                <a:gridCol w="1591056">
                  <a:extLst>
                    <a:ext uri="{9D8B030D-6E8A-4147-A177-3AD203B41FA5}">
                      <a16:colId xmlns:a16="http://schemas.microsoft.com/office/drawing/2014/main" val="1766953054"/>
                    </a:ext>
                  </a:extLst>
                </a:gridCol>
                <a:gridCol w="1234440">
                  <a:extLst>
                    <a:ext uri="{9D8B030D-6E8A-4147-A177-3AD203B41FA5}">
                      <a16:colId xmlns:a16="http://schemas.microsoft.com/office/drawing/2014/main" val="1141629462"/>
                    </a:ext>
                  </a:extLst>
                </a:gridCol>
              </a:tblGrid>
              <a:tr h="365492">
                <a:tc gridSpan="4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Table S1. Mean and standard deviation of radial strain for healthy volunteers and patients.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52252978"/>
                  </a:ext>
                </a:extLst>
              </a:tr>
              <a:tr h="74790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 </a:t>
                      </a:r>
                      <a:endParaRPr lang="en-US" sz="1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Healthy volunteers</a:t>
                      </a:r>
                      <a:endParaRPr lang="en-US" sz="1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>
                          <a:effectLst/>
                        </a:rPr>
                        <a:t>Mix of volunteers and patients</a:t>
                      </a:r>
                      <a:endParaRPr lang="en-US" sz="14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Patients</a:t>
                      </a:r>
                      <a:endParaRPr lang="en-US" sz="1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033375048"/>
                  </a:ext>
                </a:extLst>
              </a:tr>
              <a:tr h="365492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Global average E</a:t>
                      </a:r>
                      <a:r>
                        <a:rPr lang="en-US" sz="1400" baseline="-25000" dirty="0">
                          <a:effectLst/>
                        </a:rPr>
                        <a:t>rr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32±0.17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28±0.17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23±0.16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600296679"/>
                  </a:ext>
                </a:extLst>
              </a:tr>
              <a:tr h="365492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Base average E</a:t>
                      </a:r>
                      <a:r>
                        <a:rPr lang="en-US" sz="1400" baseline="-25000" dirty="0">
                          <a:effectLst/>
                        </a:rPr>
                        <a:t>rr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4±0.2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37±0.21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32±0.21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301769961"/>
                  </a:ext>
                </a:extLst>
              </a:tr>
              <a:tr h="365492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Mid-ventricular average E</a:t>
                      </a:r>
                      <a:r>
                        <a:rPr lang="en-US" sz="1400" baseline="-25000" dirty="0">
                          <a:effectLst/>
                        </a:rPr>
                        <a:t>rr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35±0.14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31±0.17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25±0.19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877384902"/>
                  </a:ext>
                </a:extLst>
              </a:tr>
              <a:tr h="365492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Apex average E</a:t>
                      </a:r>
                      <a:r>
                        <a:rPr lang="en-US" sz="1400" baseline="-25000" dirty="0">
                          <a:effectLst/>
                        </a:rPr>
                        <a:t>rr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25±0.19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24±0.18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0.23±0.17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035174514"/>
                  </a:ext>
                </a:extLst>
              </a:tr>
            </a:tbl>
          </a:graphicData>
        </a:graphic>
      </p:graphicFrame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85CC8FDB-4E52-4EC7-8B69-EE0BF06E4DC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98562534"/>
              </p:ext>
            </p:extLst>
          </p:nvPr>
        </p:nvGraphicFramePr>
        <p:xfrm>
          <a:off x="1271016" y="3810000"/>
          <a:ext cx="6245351" cy="2656344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2231135">
                  <a:extLst>
                    <a:ext uri="{9D8B030D-6E8A-4147-A177-3AD203B41FA5}">
                      <a16:colId xmlns:a16="http://schemas.microsoft.com/office/drawing/2014/main" val="3646393260"/>
                    </a:ext>
                  </a:extLst>
                </a:gridCol>
                <a:gridCol w="1188720">
                  <a:extLst>
                    <a:ext uri="{9D8B030D-6E8A-4147-A177-3AD203B41FA5}">
                      <a16:colId xmlns:a16="http://schemas.microsoft.com/office/drawing/2014/main" val="1863042051"/>
                    </a:ext>
                  </a:extLst>
                </a:gridCol>
                <a:gridCol w="1591056">
                  <a:extLst>
                    <a:ext uri="{9D8B030D-6E8A-4147-A177-3AD203B41FA5}">
                      <a16:colId xmlns:a16="http://schemas.microsoft.com/office/drawing/2014/main" val="1766953054"/>
                    </a:ext>
                  </a:extLst>
                </a:gridCol>
                <a:gridCol w="1234440">
                  <a:extLst>
                    <a:ext uri="{9D8B030D-6E8A-4147-A177-3AD203B41FA5}">
                      <a16:colId xmlns:a16="http://schemas.microsoft.com/office/drawing/2014/main" val="1141629462"/>
                    </a:ext>
                  </a:extLst>
                </a:gridCol>
              </a:tblGrid>
              <a:tr h="365492">
                <a:tc gridSpan="4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Table S2. Mean and standard deviation of circumferential strain for healthy volunteers and patients.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52252978"/>
                  </a:ext>
                </a:extLst>
              </a:tr>
              <a:tr h="74790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 </a:t>
                      </a:r>
                      <a:endParaRPr lang="en-US" sz="1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Healthy volunteers</a:t>
                      </a:r>
                      <a:endParaRPr lang="en-US" sz="1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>
                          <a:effectLst/>
                        </a:rPr>
                        <a:t>Mix of volunteers and patients</a:t>
                      </a:r>
                      <a:endParaRPr lang="en-US" sz="14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Patients</a:t>
                      </a:r>
                      <a:endParaRPr lang="en-US" sz="1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033375048"/>
                  </a:ext>
                </a:extLst>
              </a:tr>
              <a:tr h="365492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lobal average E</a:t>
                      </a:r>
                      <a:r>
                        <a:rPr lang="en-US" sz="1400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c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17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5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14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7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1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7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600296679"/>
                  </a:ext>
                </a:extLst>
              </a:tr>
              <a:tr h="365492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ase average E</a:t>
                      </a:r>
                      <a:r>
                        <a:rPr lang="en-US" sz="1400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c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17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4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14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6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1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6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301769961"/>
                  </a:ext>
                </a:extLst>
              </a:tr>
              <a:tr h="365492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id-ventricular average E</a:t>
                      </a:r>
                      <a:r>
                        <a:rPr lang="en-US" sz="1400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c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18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3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14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7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1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8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877384902"/>
                  </a:ext>
                </a:extLst>
              </a:tr>
              <a:tr h="365492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pex average E</a:t>
                      </a:r>
                      <a:r>
                        <a:rPr lang="en-US" sz="1400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c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2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4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17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7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14</a:t>
                      </a: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</a:t>
                      </a: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7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03517451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032538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2</TotalTime>
  <Words>149</Words>
  <Application>Microsoft Office PowerPoint</Application>
  <PresentationFormat>Widescreen</PresentationFormat>
  <Paragraphs>4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hadimi, Sona (sq9qd)</dc:creator>
  <cp:lastModifiedBy>Ghadimi, Sona (sq9qd)</cp:lastModifiedBy>
  <cp:revision>16</cp:revision>
  <dcterms:created xsi:type="dcterms:W3CDTF">2020-09-23T15:47:35Z</dcterms:created>
  <dcterms:modified xsi:type="dcterms:W3CDTF">2020-11-25T15:32:26Z</dcterms:modified>
</cp:coreProperties>
</file>